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4114800" cy="2743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316" autoAdjust="0"/>
    <p:restoredTop sz="94660"/>
  </p:normalViewPr>
  <p:slideViewPr>
    <p:cSldViewPr>
      <p:cViewPr varScale="1">
        <p:scale>
          <a:sx n="180" d="100"/>
          <a:sy n="180" d="100"/>
        </p:scale>
        <p:origin x="1253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182880" cy="18288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8610" y="448945"/>
            <a:ext cx="3497580" cy="955040"/>
          </a:xfrm>
        </p:spPr>
        <p:txBody>
          <a:bodyPr anchor="b"/>
          <a:lstStyle>
            <a:lvl1pPr algn="ctr"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14350" y="1440815"/>
            <a:ext cx="3086100" cy="662305"/>
          </a:xfrm>
        </p:spPr>
        <p:txBody>
          <a:bodyPr/>
          <a:lstStyle>
            <a:lvl1pPr marL="0" indent="0" algn="ctr">
              <a:buNone/>
              <a:defRPr sz="960"/>
            </a:lvl1pPr>
            <a:lvl2pPr marL="182880" indent="0" algn="ctr">
              <a:buNone/>
              <a:defRPr sz="800"/>
            </a:lvl2pPr>
            <a:lvl3pPr marL="365760" indent="0" algn="ctr">
              <a:buNone/>
              <a:defRPr sz="720"/>
            </a:lvl3pPr>
            <a:lvl4pPr marL="548640" indent="0" algn="ctr">
              <a:buNone/>
              <a:defRPr sz="640"/>
            </a:lvl4pPr>
            <a:lvl5pPr marL="731520" indent="0" algn="ctr">
              <a:buNone/>
              <a:defRPr sz="640"/>
            </a:lvl5pPr>
            <a:lvl6pPr marL="914400" indent="0" algn="ctr">
              <a:buNone/>
              <a:defRPr sz="640"/>
            </a:lvl6pPr>
            <a:lvl7pPr marL="1097280" indent="0" algn="ctr">
              <a:buNone/>
              <a:defRPr sz="640"/>
            </a:lvl7pPr>
            <a:lvl8pPr marL="1280160" indent="0" algn="ctr">
              <a:buNone/>
              <a:defRPr sz="640"/>
            </a:lvl8pPr>
            <a:lvl9pPr marL="1463040" indent="0" algn="ctr">
              <a:buNone/>
              <a:defRPr sz="6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720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355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944654" y="146050"/>
            <a:ext cx="887254" cy="23247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2893" y="146050"/>
            <a:ext cx="2610326" cy="232473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940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028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0750" y="683896"/>
            <a:ext cx="3549015" cy="114109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0750" y="1835786"/>
            <a:ext cx="3549015" cy="600075"/>
          </a:xfrm>
        </p:spPr>
        <p:txBody>
          <a:bodyPr/>
          <a:lstStyle>
            <a:lvl1pPr marL="0" indent="0">
              <a:buNone/>
              <a:defRPr sz="960">
                <a:solidFill>
                  <a:schemeClr val="tx1"/>
                </a:solidFill>
              </a:defRPr>
            </a:lvl1pPr>
            <a:lvl2pPr marL="18288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2pPr>
            <a:lvl3pPr marL="365760" indent="0">
              <a:buNone/>
              <a:defRPr sz="720">
                <a:solidFill>
                  <a:schemeClr val="tx1">
                    <a:tint val="75000"/>
                  </a:schemeClr>
                </a:solidFill>
              </a:defRPr>
            </a:lvl3pPr>
            <a:lvl4pPr marL="5486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4pPr>
            <a:lvl5pPr marL="73152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5pPr>
            <a:lvl6pPr marL="91440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6pPr>
            <a:lvl7pPr marL="109728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7pPr>
            <a:lvl8pPr marL="128016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8pPr>
            <a:lvl9pPr marL="14630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871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2893" y="730250"/>
            <a:ext cx="1748790" cy="17405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3118" y="730250"/>
            <a:ext cx="1748790" cy="17405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783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28" y="146051"/>
            <a:ext cx="3549015" cy="5302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3429" y="672465"/>
            <a:ext cx="1740753" cy="329565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3429" y="1002030"/>
            <a:ext cx="1740753" cy="14738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83118" y="672465"/>
            <a:ext cx="1749326" cy="329565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83118" y="1002030"/>
            <a:ext cx="1749326" cy="14738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454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423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640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29" y="182880"/>
            <a:ext cx="1327130" cy="64008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49326" y="394971"/>
            <a:ext cx="2083118" cy="1949450"/>
          </a:xfrm>
        </p:spPr>
        <p:txBody>
          <a:bodyPr/>
          <a:lstStyle>
            <a:lvl1pPr>
              <a:defRPr sz="1280"/>
            </a:lvl1pPr>
            <a:lvl2pPr>
              <a:defRPr sz="1120"/>
            </a:lvl2pPr>
            <a:lvl3pPr>
              <a:defRPr sz="96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3429" y="822960"/>
            <a:ext cx="1327130" cy="1524635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701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29" y="182880"/>
            <a:ext cx="1327130" cy="64008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49326" y="394971"/>
            <a:ext cx="2083118" cy="1949450"/>
          </a:xfrm>
        </p:spPr>
        <p:txBody>
          <a:bodyPr anchor="t"/>
          <a:lstStyle>
            <a:lvl1pPr marL="0" indent="0">
              <a:buNone/>
              <a:defRPr sz="1280"/>
            </a:lvl1pPr>
            <a:lvl2pPr marL="182880" indent="0">
              <a:buNone/>
              <a:defRPr sz="1120"/>
            </a:lvl2pPr>
            <a:lvl3pPr marL="365760" indent="0">
              <a:buNone/>
              <a:defRPr sz="960"/>
            </a:lvl3pPr>
            <a:lvl4pPr marL="548640" indent="0">
              <a:buNone/>
              <a:defRPr sz="800"/>
            </a:lvl4pPr>
            <a:lvl5pPr marL="731520" indent="0">
              <a:buNone/>
              <a:defRPr sz="800"/>
            </a:lvl5pPr>
            <a:lvl6pPr marL="914400" indent="0">
              <a:buNone/>
              <a:defRPr sz="800"/>
            </a:lvl6pPr>
            <a:lvl7pPr marL="1097280" indent="0">
              <a:buNone/>
              <a:defRPr sz="800"/>
            </a:lvl7pPr>
            <a:lvl8pPr marL="1280160" indent="0">
              <a:buNone/>
              <a:defRPr sz="800"/>
            </a:lvl8pPr>
            <a:lvl9pPr marL="1463040" indent="0">
              <a:buNone/>
              <a:defRPr sz="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3429" y="822960"/>
            <a:ext cx="1327130" cy="1524635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247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82893" y="146051"/>
            <a:ext cx="3549015" cy="53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2893" y="730250"/>
            <a:ext cx="3549015" cy="17405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82893" y="2542541"/>
            <a:ext cx="92583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C2BF1-E547-497B-8D94-F4CA947BAF73}" type="datetimeFigureOut">
              <a:rPr lang="en-US" smtClean="0"/>
              <a:t>4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63028" y="2542541"/>
            <a:ext cx="1388745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906078" y="2542541"/>
            <a:ext cx="92583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E3CC3-88E0-4AB1-8833-2FCECEC33C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190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65760" rtl="0" eaLnBrk="1" latinLnBrk="0" hangingPunct="1">
        <a:lnSpc>
          <a:spcPct val="90000"/>
        </a:lnSpc>
        <a:spcBef>
          <a:spcPct val="0"/>
        </a:spcBef>
        <a:buNone/>
        <a:defRPr sz="17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36576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12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Rectangle 80">
            <a:extLst>
              <a:ext uri="{FF2B5EF4-FFF2-40B4-BE49-F238E27FC236}">
                <a16:creationId xmlns:a16="http://schemas.microsoft.com/office/drawing/2014/main" id="{606956A8-9D0E-2A7B-1D06-E0C0EAF291B3}"/>
              </a:ext>
            </a:extLst>
          </p:cNvPr>
          <p:cNvSpPr/>
          <p:nvPr/>
        </p:nvSpPr>
        <p:spPr>
          <a:xfrm>
            <a:off x="931200" y="2599453"/>
            <a:ext cx="1074420" cy="13302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tive Protein Structure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1AC5E4AA-BABF-3FD2-F6A4-77E6F5CC32D4}"/>
              </a:ext>
            </a:extLst>
          </p:cNvPr>
          <p:cNvSpPr/>
          <p:nvPr/>
        </p:nvSpPr>
        <p:spPr>
          <a:xfrm>
            <a:off x="2582801" y="2599453"/>
            <a:ext cx="1293822" cy="13302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timized Protein Structure</a:t>
            </a:r>
          </a:p>
        </p:txBody>
      </p:sp>
      <p:grpSp>
        <p:nvGrpSpPr>
          <p:cNvPr id="83" name="Group 82">
            <a:extLst>
              <a:ext uri="{FF2B5EF4-FFF2-40B4-BE49-F238E27FC236}">
                <a16:creationId xmlns:a16="http://schemas.microsoft.com/office/drawing/2014/main" id="{0AAA7659-6272-F3A2-6085-1ABA8C0A9AB9}"/>
              </a:ext>
            </a:extLst>
          </p:cNvPr>
          <p:cNvGrpSpPr/>
          <p:nvPr/>
        </p:nvGrpSpPr>
        <p:grpSpPr>
          <a:xfrm>
            <a:off x="-95619" y="1188720"/>
            <a:ext cx="1221577" cy="706664"/>
            <a:chOff x="102237" y="1493023"/>
            <a:chExt cx="1221577" cy="706664"/>
          </a:xfrm>
        </p:grpSpPr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A7E9187A-CA8D-9641-FD23-674153828C41}"/>
                </a:ext>
              </a:extLst>
            </p:cNvPr>
            <p:cNvGrpSpPr/>
            <p:nvPr/>
          </p:nvGrpSpPr>
          <p:grpSpPr>
            <a:xfrm>
              <a:off x="542375" y="1671753"/>
              <a:ext cx="569837" cy="347699"/>
              <a:chOff x="1461243" y="2046457"/>
              <a:chExt cx="569837" cy="347699"/>
            </a:xfrm>
          </p:grpSpPr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058FDC38-F932-F284-121D-7F2C4692FDC4}"/>
                  </a:ext>
                </a:extLst>
              </p:cNvPr>
              <p:cNvSpPr/>
              <p:nvPr/>
            </p:nvSpPr>
            <p:spPr>
              <a:xfrm>
                <a:off x="1461243" y="2046457"/>
                <a:ext cx="569833" cy="10089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>
                    <a:solidFill>
                      <a:srgbClr val="517D33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in A</a:t>
                </a:r>
              </a:p>
            </p:txBody>
          </p: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DDC05C5E-BF8A-A285-0E50-1132A41A4A4C}"/>
                  </a:ext>
                </a:extLst>
              </p:cNvPr>
              <p:cNvSpPr/>
              <p:nvPr/>
            </p:nvSpPr>
            <p:spPr>
              <a:xfrm>
                <a:off x="1461246" y="2287872"/>
                <a:ext cx="569832" cy="10628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>
                    <a:solidFill>
                      <a:srgbClr val="95590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in C</a:t>
                </a:r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783FAC48-8BBE-406C-1A4A-661FFFB80870}"/>
                  </a:ext>
                </a:extLst>
              </p:cNvPr>
              <p:cNvSpPr/>
              <p:nvPr/>
            </p:nvSpPr>
            <p:spPr>
              <a:xfrm>
                <a:off x="1461245" y="2173909"/>
                <a:ext cx="569835" cy="8572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>
                    <a:solidFill>
                      <a:srgbClr val="255D8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in B</a:t>
                </a:r>
              </a:p>
            </p:txBody>
          </p:sp>
        </p:grp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EB939FE2-6FDC-6629-E2A4-B9341F4F3BC2}"/>
                </a:ext>
              </a:extLst>
            </p:cNvPr>
            <p:cNvSpPr/>
            <p:nvPr/>
          </p:nvSpPr>
          <p:spPr>
            <a:xfrm>
              <a:off x="334439" y="2110533"/>
              <a:ext cx="989375" cy="8915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rgbClr val="7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teroatoms &amp; Water Molecules</a:t>
              </a:r>
            </a:p>
          </p:txBody>
        </p:sp>
        <p:sp>
          <p:nvSpPr>
            <p:cNvPr id="86" name="Rounded Rectangle 31">
              <a:extLst>
                <a:ext uri="{FF2B5EF4-FFF2-40B4-BE49-F238E27FC236}">
                  <a16:creationId xmlns:a16="http://schemas.microsoft.com/office/drawing/2014/main" id="{2ACA182E-7B83-24B9-4F4C-A3580521C17B}"/>
                </a:ext>
              </a:extLst>
            </p:cNvPr>
            <p:cNvSpPr/>
            <p:nvPr/>
          </p:nvSpPr>
          <p:spPr>
            <a:xfrm>
              <a:off x="614913" y="1644750"/>
              <a:ext cx="428424" cy="401707"/>
            </a:xfrm>
            <a:prstGeom prst="round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91F49CDA-0E1E-DA19-7103-2EFE5CC3F2A2}"/>
                </a:ext>
              </a:extLst>
            </p:cNvPr>
            <p:cNvCxnSpPr>
              <a:cxnSpLocks/>
            </p:cNvCxnSpPr>
            <p:nvPr/>
          </p:nvCxnSpPr>
          <p:spPr>
            <a:xfrm>
              <a:off x="228600" y="2119994"/>
              <a:ext cx="18467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2E9D8A36-0EA0-7DFB-B063-7607C420AE2C}"/>
                </a:ext>
              </a:extLst>
            </p:cNvPr>
            <p:cNvCxnSpPr/>
            <p:nvPr/>
          </p:nvCxnSpPr>
          <p:spPr>
            <a:xfrm flipV="1">
              <a:off x="228600" y="1831958"/>
              <a:ext cx="0" cy="28803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F6DF7B0D-1C4F-84CF-AF2B-3545CB432F1D}"/>
                </a:ext>
              </a:extLst>
            </p:cNvPr>
            <p:cNvCxnSpPr>
              <a:cxnSpLocks/>
            </p:cNvCxnSpPr>
            <p:nvPr/>
          </p:nvCxnSpPr>
          <p:spPr>
            <a:xfrm>
              <a:off x="228600" y="1833661"/>
              <a:ext cx="38781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240221CA-21B4-FC76-42D1-E52FBB478F8D}"/>
                </a:ext>
              </a:extLst>
            </p:cNvPr>
            <p:cNvSpPr/>
            <p:nvPr/>
          </p:nvSpPr>
          <p:spPr>
            <a:xfrm>
              <a:off x="102237" y="1720797"/>
              <a:ext cx="639041" cy="8841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lex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EFB68C75-A6D2-EA0C-6D37-502C90247C0A}"/>
                </a:ext>
              </a:extLst>
            </p:cNvPr>
            <p:cNvSpPr/>
            <p:nvPr/>
          </p:nvSpPr>
          <p:spPr>
            <a:xfrm>
              <a:off x="369058" y="1493023"/>
              <a:ext cx="916466" cy="124302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ma1 Trimer</a:t>
              </a: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00A2AD36-7480-1860-78E9-DC5AB1A4578E}"/>
              </a:ext>
            </a:extLst>
          </p:cNvPr>
          <p:cNvGrpSpPr/>
          <p:nvPr/>
        </p:nvGrpSpPr>
        <p:grpSpPr>
          <a:xfrm>
            <a:off x="3337560" y="1188720"/>
            <a:ext cx="1067682" cy="306517"/>
            <a:chOff x="2977855" y="720154"/>
            <a:chExt cx="1067682" cy="306517"/>
          </a:xfrm>
        </p:grpSpPr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3A3DC78C-8B1F-3418-3EA3-C01E50FAB288}"/>
                </a:ext>
              </a:extLst>
            </p:cNvPr>
            <p:cNvSpPr/>
            <p:nvPr/>
          </p:nvSpPr>
          <p:spPr>
            <a:xfrm>
              <a:off x="3136215" y="884321"/>
              <a:ext cx="569826" cy="11660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ain A</a:t>
              </a: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866BA99C-D756-807A-723F-1F5843A99BB0}"/>
                </a:ext>
              </a:extLst>
            </p:cNvPr>
            <p:cNvSpPr/>
            <p:nvPr/>
          </p:nvSpPr>
          <p:spPr>
            <a:xfrm>
              <a:off x="2977855" y="720154"/>
              <a:ext cx="1067682" cy="124302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ma1 Monomer</a:t>
              </a:r>
            </a:p>
          </p:txBody>
        </p:sp>
        <p:sp>
          <p:nvSpPr>
            <p:cNvPr id="98" name="Rounded Rectangle 53">
              <a:extLst>
                <a:ext uri="{FF2B5EF4-FFF2-40B4-BE49-F238E27FC236}">
                  <a16:creationId xmlns:a16="http://schemas.microsoft.com/office/drawing/2014/main" id="{8640DB6A-7CBD-2AAE-47E7-BD22B29F7FAF}"/>
                </a:ext>
              </a:extLst>
            </p:cNvPr>
            <p:cNvSpPr/>
            <p:nvPr/>
          </p:nvSpPr>
          <p:spPr>
            <a:xfrm>
              <a:off x="3209514" y="868680"/>
              <a:ext cx="433064" cy="157991"/>
            </a:xfrm>
            <a:prstGeom prst="round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A1C33646-098E-A61F-CB62-DB34B1665FF8}"/>
              </a:ext>
            </a:extLst>
          </p:cNvPr>
          <p:cNvGrpSpPr/>
          <p:nvPr/>
        </p:nvGrpSpPr>
        <p:grpSpPr>
          <a:xfrm>
            <a:off x="1778120" y="1392043"/>
            <a:ext cx="1067682" cy="152598"/>
            <a:chOff x="1789083" y="1649254"/>
            <a:chExt cx="1067682" cy="152598"/>
          </a:xfrm>
        </p:grpSpPr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1C693232-1DFD-7FEA-9E07-419E16CC63D4}"/>
                </a:ext>
              </a:extLst>
            </p:cNvPr>
            <p:cNvCxnSpPr>
              <a:cxnSpLocks/>
            </p:cNvCxnSpPr>
            <p:nvPr/>
          </p:nvCxnSpPr>
          <p:spPr>
            <a:xfrm>
              <a:off x="1885483" y="1686613"/>
              <a:ext cx="97128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8ED18A74-F2AA-CFD3-AFCE-AF251BE7F0A1}"/>
                </a:ext>
              </a:extLst>
            </p:cNvPr>
            <p:cNvSpPr/>
            <p:nvPr/>
          </p:nvSpPr>
          <p:spPr>
            <a:xfrm>
              <a:off x="1789083" y="1649254"/>
              <a:ext cx="1067682" cy="1525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tein optimization by</a:t>
              </a:r>
            </a:p>
            <a:p>
              <a:pPr algn="ctr"/>
              <a:endParaRPr 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MOS 43B1 force field </a:t>
              </a:r>
            </a:p>
          </p:txBody>
        </p:sp>
      </p:grpSp>
      <p:pic>
        <p:nvPicPr>
          <p:cNvPr id="107" name="Picture 106">
            <a:extLst>
              <a:ext uri="{FF2B5EF4-FFF2-40B4-BE49-F238E27FC236}">
                <a16:creationId xmlns:a16="http://schemas.microsoft.com/office/drawing/2014/main" id="{2362B73C-211B-509D-EF5B-88505D95FB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566" y="63215"/>
            <a:ext cx="4449676" cy="2732373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BC48DD5D-FEBE-58D1-2929-B805DAA846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95185" y="-1497"/>
            <a:ext cx="4458666" cy="2737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6531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</TotalTime>
  <Words>30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one</dc:creator>
  <cp:lastModifiedBy>Zone</cp:lastModifiedBy>
  <cp:revision>1</cp:revision>
  <dcterms:created xsi:type="dcterms:W3CDTF">2026-04-03T23:43:15Z</dcterms:created>
  <dcterms:modified xsi:type="dcterms:W3CDTF">2026-04-04T00:07:08Z</dcterms:modified>
</cp:coreProperties>
</file>